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4678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867E3-E5C6-41B5-BD5A-36D899FC52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6172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473440"/>
            <a:ext cx="6172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42852-EFBF-4F3A-8886-D9379E3D04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47344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47344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7B74B-4018-4038-9217-788C18606D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20932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20932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47344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47344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473440"/>
            <a:ext cx="1987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715DF-2DE4-4833-BBBB-33FA7531EB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209320"/>
            <a:ext cx="6172200" cy="624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E2CA8-A36E-416B-92EA-2DAE13255D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617220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EDCCA-5A3B-4181-BDDE-89A64493C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301176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209320"/>
            <a:ext cx="301176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2D1E3-3D68-48AC-890D-2C1B4B7A04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3445D-E7D2-4255-B470-87BC42D986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79080"/>
            <a:ext cx="6172200" cy="731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44744-B94D-47D6-9A7E-5B2E3C080B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209320"/>
            <a:ext cx="301176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47344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405A8-F090-41FC-97B2-62EC7209E7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301176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47344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EBD88-E02E-41FD-A613-923D3CB850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209320"/>
            <a:ext cx="301176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473440"/>
            <a:ext cx="6172200" cy="298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E2C32-96E4-495A-9175-48244E0A9C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79080"/>
            <a:ext cx="61722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209320"/>
            <a:ext cx="6172200" cy="624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623080"/>
            <a:ext cx="160020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623080"/>
            <a:ext cx="217152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623080"/>
            <a:ext cx="1600200" cy="65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5781A4-21CF-4592-A633-54262FD5A3A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5"/>
          <p:cNvGrpSpPr/>
          <p:nvPr/>
        </p:nvGrpSpPr>
        <p:grpSpPr>
          <a:xfrm>
            <a:off x="156240" y="1108080"/>
            <a:ext cx="6487200" cy="7628040"/>
            <a:chOff x="156240" y="1108080"/>
            <a:chExt cx="6487200" cy="7628040"/>
          </a:xfrm>
        </p:grpSpPr>
        <p:graphicFrame>
          <p:nvGraphicFramePr>
            <p:cNvPr id="42" name="Object 4"/>
            <p:cNvGraphicFramePr/>
            <p:nvPr/>
          </p:nvGraphicFramePr>
          <p:xfrm>
            <a:off x="1077840" y="1108080"/>
            <a:ext cx="5565600" cy="7628040"/>
          </p:xfrm>
          <a:graphic>
            <a:graphicData uri="http://schemas.openxmlformats.org/presentationml/2006/ole">
              <p:oleObj progId="Word.Document.12" r:id="rId1" spid="">
                <p:embed/>
                <p:pic>
                  <p:nvPicPr>
                    <p:cNvPr id="43" name="Object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77840" y="1108080"/>
                      <a:ext cx="5565600" cy="7628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AutoShape 6"/>
            <p:cNvSpPr/>
            <p:nvPr/>
          </p:nvSpPr>
          <p:spPr>
            <a:xfrm>
              <a:off x="1293480" y="1506600"/>
              <a:ext cx="216000" cy="1987560"/>
            </a:xfrm>
            <a:custGeom>
              <a:avLst/>
              <a:gdLst>
                <a:gd name="textAreaLeft" fmla="*/ 137880 w 216000"/>
                <a:gd name="textAreaRight" fmla="*/ 216360 w 216000"/>
                <a:gd name="textAreaTop" fmla="*/ 51840 h 1987560"/>
                <a:gd name="textAreaBottom" fmla="*/ 1935720 h 1987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AutoShape 7"/>
            <p:cNvSpPr/>
            <p:nvPr/>
          </p:nvSpPr>
          <p:spPr>
            <a:xfrm>
              <a:off x="1379160" y="5112000"/>
              <a:ext cx="130320" cy="3587760"/>
            </a:xfrm>
            <a:custGeom>
              <a:avLst/>
              <a:gdLst>
                <a:gd name="textAreaLeft" fmla="*/ 83160 w 130320"/>
                <a:gd name="textAreaRight" fmla="*/ 130680 w 130320"/>
                <a:gd name="textAreaTop" fmla="*/ 93240 h 3587760"/>
                <a:gd name="textAreaBottom" fmla="*/ 3494520 h 3587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AutoShape 8"/>
            <p:cNvSpPr/>
            <p:nvPr/>
          </p:nvSpPr>
          <p:spPr>
            <a:xfrm>
              <a:off x="1417320" y="4392720"/>
              <a:ext cx="71640" cy="658800"/>
            </a:xfrm>
            <a:custGeom>
              <a:avLst/>
              <a:gdLst>
                <a:gd name="textAreaLeft" fmla="*/ 45720 w 71640"/>
                <a:gd name="textAreaRight" fmla="*/ 72000 w 71640"/>
                <a:gd name="textAreaTop" fmla="*/ 16920 h 658800"/>
                <a:gd name="textAreaBottom" fmla="*/ 641880 h 6588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203040" y="2168640"/>
              <a:ext cx="1052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3399"/>
                  </a:solidFill>
                  <a:latin typeface="Arial"/>
                </a:rPr>
                <a:t>N. sik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0"/>
            <p:cNvSpPr/>
            <p:nvPr/>
          </p:nvSpPr>
          <p:spPr>
            <a:xfrm>
              <a:off x="203040" y="3625920"/>
              <a:ext cx="12952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3300"/>
                  </a:solidFill>
                  <a:latin typeface="Arial"/>
                </a:rPr>
                <a:t>N. leucogeny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1"/>
            <p:cNvSpPr/>
            <p:nvPr/>
          </p:nvSpPr>
          <p:spPr>
            <a:xfrm>
              <a:off x="156240" y="6715080"/>
              <a:ext cx="12002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808000"/>
                  </a:solidFill>
                  <a:latin typeface="Arial"/>
                </a:rPr>
                <a:t>N. annam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2"/>
            <p:cNvSpPr/>
            <p:nvPr/>
          </p:nvSpPr>
          <p:spPr>
            <a:xfrm>
              <a:off x="214560" y="4502160"/>
              <a:ext cx="103860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cc00"/>
                  </a:solidFill>
                  <a:latin typeface="Arial"/>
                </a:rPr>
                <a:t>N. gabriell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AutoShape 13"/>
            <p:cNvSpPr/>
            <p:nvPr/>
          </p:nvSpPr>
          <p:spPr>
            <a:xfrm>
              <a:off x="1461960" y="3521160"/>
              <a:ext cx="120600" cy="785880"/>
            </a:xfrm>
            <a:custGeom>
              <a:avLst/>
              <a:gdLst>
                <a:gd name="textAreaLeft" fmla="*/ 77040 w 120600"/>
                <a:gd name="textAreaRight" fmla="*/ 120960 w 120600"/>
                <a:gd name="textAreaTop" fmla="*/ 20160 h 785880"/>
                <a:gd name="textAreaBottom" fmla="*/ 765720 h 785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Rectangle 14"/>
          <p:cNvSpPr/>
          <p:nvPr/>
        </p:nvSpPr>
        <p:spPr>
          <a:xfrm>
            <a:off x="0" y="487440"/>
            <a:ext cx="685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File 3: Dendrogram of hierarchical cluster analysis showing the acoustic dissimilarity between the four southern spec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7T04:09:10Z</dcterms:created>
  <dc:creator>thinh</dc:creator>
  <dc:description/>
  <dc:language>en-US</dc:language>
  <cp:lastModifiedBy>KH</cp:lastModifiedBy>
  <dcterms:modified xsi:type="dcterms:W3CDTF">2010-12-22T15:27:29Z</dcterms:modified>
  <cp:revision>17</cp:revision>
  <dc:subject/>
  <dc:title>Slide 1</dc:title>
</cp:coreProperties>
</file>